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40"/>
    <p:restoredTop sz="75714"/>
  </p:normalViewPr>
  <p:slideViewPr>
    <p:cSldViewPr snapToGrid="0">
      <p:cViewPr varScale="1">
        <p:scale>
          <a:sx n="56" d="100"/>
          <a:sy n="56" d="100"/>
        </p:scale>
        <p:origin x="122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68D6B6-4E74-1845-9767-73F29AD6F1C6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5801DC-0F8B-D049-AD50-C71668A085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7300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defTabSz="685800">
              <a:defRPr/>
            </a:pP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calization of TJ proteins at 4- and 9-hours post co-culture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fluorescence labeled as the nucleus (blue), ZO-1 &amp; occludin (green)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falciparum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red)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 &amp; B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O-1 expression in hiPSC-derived BMECs co-cultured with RBCs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 &amp; D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ccludin expression in hiPSC-derived BMECs co-cultured with RBCs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. The red box indicates discontinuous junctions.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gital zoomed images show these breaks. Scale bar=100 µ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5801DC-0F8B-D049-AD50-C71668A0853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599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217042A-117D-3522-D7E9-507066AABA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4FA45A45-B34E-EDCC-3A0D-299CA6D241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DE8931E-37E2-2040-2BD6-30247125D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038A647-C9AD-88C1-5A75-48D4D923D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DC23A34-0845-A630-BCB5-0A4F20179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287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78603A3-EBC5-60A5-2C51-768A897CF7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5A55BE58-20AE-0951-5572-60D3C39175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2036410-1EED-990A-FF4D-B5E8279B3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55A2A2D-438E-958E-F58B-C09A994BF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9A3CECF-39B3-B60E-B620-DBF8C37DF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427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99633504-04CF-3CFD-D2F5-E7EAFD7106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E88CCE6C-46C8-BE0F-8635-2C5C9D1943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C5F5A48-0D1C-34AD-15FD-5B4816948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1FC3723-D413-2461-F94B-7E33B9688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37E4675-CDF3-C21D-09B7-304FD09A1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955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FBEF789-96E7-5DBA-C819-6F3CB41199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82B748D1-51C1-6B69-A0C8-9F3481BE7C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C32A13D-2D81-F1FF-D6E4-CD071BD99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A45B915-AA31-1C0F-445F-FB85C5D14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09CA78E-6CD8-DF2A-B4AC-E4860C58C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640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1A97AEE-5A6E-1D72-45EB-368D4D9F36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5D20E30-85C2-ABB6-DCB7-384E97F198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2253B4C-3D04-9F28-984F-990A0DA01C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DF05443-66BE-4354-F6A8-9F9452049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8AE438D-5554-683B-0EC6-734B5ABE6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247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F7FCA14-3485-0B13-DE1F-F07DD799D4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9325CCD-CB77-7ADE-1E63-01FDC3F9A3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94709544-2AF6-BE8E-A456-096613286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C3F1732C-E7A0-5520-8AA8-62049BB83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3519BDF-4D35-188B-74E2-4F4C09E4A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59347F1C-E56B-C90A-2214-887A0B2A1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939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C28A6A3-2E83-8548-CDB5-3127590B4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D3F23BD-4234-B769-1F7B-F7BA675162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0CFE2269-DBDD-3A70-E778-E7C1C4FD4F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F16DB724-28AD-9F29-B598-788F04D357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00351EE8-8286-4245-104A-46379242B5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824009BB-DCD1-DBFB-7D75-505B8E66A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A3F34137-2350-9A2E-30B5-065D3A8DE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EB748662-4DA3-E774-D3E9-629B455B8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95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A9847B4-CB03-A410-7DF7-D8D783434F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45EFD225-07E1-2EA4-E439-A9A1F756D6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479388B0-4304-12DE-E88E-A79B47833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2A18E43E-41FC-75E3-C486-2A37C0858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025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43F98BE6-D518-05E3-F827-E65CC889A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2D89D22F-642D-28D7-0A5E-9D86684D1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37DC82E1-E8BB-7620-5584-5AB53397A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332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A2397E0-3CCE-45CD-E39A-7B29A74BE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62DE548-3A6B-3E5D-37A0-1A8EB801CD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5E8D9D7D-10F4-577E-398A-70DE069369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7ABDDA7-78C4-F5C8-13B4-D6866E34D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51FAE09A-FC20-B08C-027C-E807C057E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3C6B9303-904E-B382-C1EC-6BCE85D40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283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928C82E-362F-F280-51BE-5618471423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27BACF53-A10A-0121-32E9-CC6001E180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256287F2-27ED-8F9E-BF2B-27EF8B5F68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EF6C9D6-A097-7507-FFA5-EB074128C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623AC0F4-56FA-0010-A99F-F3F0DAD92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81FCF6EF-6FA0-E335-E8D0-9C4452926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967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7C70F0EE-A0F7-FA33-9E66-8A7B14BF4B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B9E4BA2B-CCF0-6196-AD4E-8CF160F7F3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CF25A5C-E288-0278-7863-08604002DF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8F2A0F-DD9C-A942-BFBF-3F6FA7E5DCFB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DBFE50B-679D-D57C-3697-1EF50980DA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2B2C7DD-5416-DC35-066E-A07A7E9D0D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6112F0-A7CA-9542-BC6F-99D78B437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172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microscope&#10;&#10;Description automatically generated">
            <a:extLst>
              <a:ext uri="{FF2B5EF4-FFF2-40B4-BE49-F238E27FC236}">
                <a16:creationId xmlns="" xmlns:a16="http://schemas.microsoft.com/office/drawing/2014/main" id="{C0CCCF5A-5D34-C958-3D0D-3261EB2B79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0857" y="331107"/>
            <a:ext cx="7807352" cy="45021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5E0CA1A3-D73B-1A17-4038-B12672B62B89}"/>
              </a:ext>
            </a:extLst>
          </p:cNvPr>
          <p:cNvSpPr txBox="1"/>
          <p:nvPr/>
        </p:nvSpPr>
        <p:spPr>
          <a:xfrm>
            <a:off x="2140857" y="5223874"/>
            <a:ext cx="7807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685800">
              <a:defRPr/>
            </a:pPr>
            <a:r>
              <a:rPr lang="en-US" sz="1000" b="1" kern="50" spc="-15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kern="50" spc="-15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lang="en-US" sz="1000" kern="50" spc="-15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ightfield images at 6-hours post co-culture. (A) hiPSC-derived BMECs cultured in media (control). (B) hiPSC-derived BMECs co-cultured with RBCs. (C) hiPSC-derived BMECs co-cultured with </a:t>
            </a:r>
            <a:r>
              <a:rPr lang="en-US" sz="1000" i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. The black boxes are digitally zoomed images. Scale bar = 74 µm. </a:t>
            </a:r>
            <a:endParaRPr 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8924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8a897e8-d4da-4754-b76c-471f0d488363">
      <Terms xmlns="http://schemas.microsoft.com/office/infopath/2007/PartnerControls"/>
    </lcf76f155ced4ddcb4097134ff3c332f>
    <TaxCatchAll xmlns="9a2030ed-2c9c-4ecf-96df-48ffd2037682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6F83623FE0101439BF9CBCA708448C2" ma:contentTypeVersion="14" ma:contentTypeDescription="Create a new document." ma:contentTypeScope="" ma:versionID="43435aca2c006b86cb5a1b4b69da5887">
  <xsd:schema xmlns:xsd="http://www.w3.org/2001/XMLSchema" xmlns:xs="http://www.w3.org/2001/XMLSchema" xmlns:p="http://schemas.microsoft.com/office/2006/metadata/properties" xmlns:ns2="88a897e8-d4da-4754-b76c-471f0d488363" xmlns:ns3="9a2030ed-2c9c-4ecf-96df-48ffd2037682" targetNamespace="http://schemas.microsoft.com/office/2006/metadata/properties" ma:root="true" ma:fieldsID="8e3ea8bdce2d7a53ced3a228efd8bbf6" ns2:_="" ns3:_="">
    <xsd:import namespace="88a897e8-d4da-4754-b76c-471f0d488363"/>
    <xsd:import namespace="9a2030ed-2c9c-4ecf-96df-48ffd203768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8a897e8-d4da-4754-b76c-471f0d48836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2030ed-2c9c-4ecf-96df-48ffd2037682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d587f133-08ee-41ab-81b8-7455cffb4ef8}" ma:internalName="TaxCatchAll" ma:showField="CatchAllData" ma:web="9a2030ed-2c9c-4ecf-96df-48ffd203768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D724347-9927-46FA-AB3D-8D52E18C0E5B}">
  <ds:schemaRefs>
    <ds:schemaRef ds:uri="http://schemas.microsoft.com/office/2006/metadata/properties"/>
    <ds:schemaRef ds:uri="http://schemas.microsoft.com/office/infopath/2007/PartnerControls"/>
    <ds:schemaRef ds:uri="88a897e8-d4da-4754-b76c-471f0d488363"/>
    <ds:schemaRef ds:uri="9a2030ed-2c9c-4ecf-96df-48ffd2037682"/>
  </ds:schemaRefs>
</ds:datastoreItem>
</file>

<file path=customXml/itemProps2.xml><?xml version="1.0" encoding="utf-8"?>
<ds:datastoreItem xmlns:ds="http://schemas.openxmlformats.org/officeDocument/2006/customXml" ds:itemID="{17251A43-4B90-4F37-A1F1-A22CCC7C8A9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8a897e8-d4da-4754-b76c-471f0d488363"/>
    <ds:schemaRef ds:uri="9a2030ed-2c9c-4ecf-96df-48ffd20376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7475128-1BDB-4D7F-99CF-3ED8ADC8A85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8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pinadhan, Adnan</dc:creator>
  <cp:lastModifiedBy>Maria Flora V.</cp:lastModifiedBy>
  <cp:revision>4</cp:revision>
  <dcterms:created xsi:type="dcterms:W3CDTF">2024-04-11T16:54:31Z</dcterms:created>
  <dcterms:modified xsi:type="dcterms:W3CDTF">2024-04-20T12:00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6F83623FE0101439BF9CBCA708448C2</vt:lpwstr>
  </property>
</Properties>
</file>